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0033"/>
    <a:srgbClr val="FFFFFF"/>
    <a:srgbClr val="00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89" autoAdjust="0"/>
    <p:restoredTop sz="94660"/>
  </p:normalViewPr>
  <p:slideViewPr>
    <p:cSldViewPr snapToGrid="0">
      <p:cViewPr varScale="1">
        <p:scale>
          <a:sx n="88" d="100"/>
          <a:sy n="88" d="100"/>
        </p:scale>
        <p:origin x="51" y="11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32A087-610C-4A2D-BFEA-E6066072FA9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36A305-A877-46CB-B3A9-E825BD77DC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27497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F4F289A-A22E-70E8-6665-B599371940B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D6E0CE64-5C21-A232-5CAC-92B983E00E51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03B76821-D822-0FCB-F776-5E66790E4C4D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DEFBC8C-BDFE-910F-1B02-98448160CA10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36A305-A877-46CB-B3A9-E825BD77DC9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84550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993D687-7917-AF96-2083-BE5DD69C6B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0AF580E-271C-8573-A3AA-4322C5765AE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D7BC2A9-1C8D-DDB1-AB7F-E525176300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A4D75D6-E805-9CF8-A5F1-0DDD97D734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F149A2D-2565-4DA1-E34A-3AC918FB2B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16369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544FA41-7EFE-6CAE-D360-A80A551A54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3220CC2-E885-8272-61F0-F9F1F656D7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FEB22F4-F981-E8C9-4BA6-3AEECA3AA8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1780BB2-32C1-5B04-739B-D23591A7F1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4A7D371-A86D-4C9F-D31D-B2F1559E41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27444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81A7970E-AA44-1220-F769-6638911B889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28A34B9-CA3F-55BD-41AF-2C33927B0D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1CFFA9D-EA35-12BA-6663-ACB7CBF7AD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45CE27D-48F2-926E-8040-12A43D0D58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7E07559-6E9F-25A2-A47A-DABDAB16AC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81369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57A45D0-D37A-BB53-3B0C-AF4E38B3DB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D9B368A-2498-49E1-645B-C20F1B3191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AD663C3-9C20-BE3B-25A6-E162F19CE9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A58F056-DA08-3D99-648D-4EDA929DE3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6ACA2E3-97EE-016D-743E-E81B67BFA4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54733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A3181D5-C4A7-38C5-319E-1E572617EA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89D4C25-2B17-4F77-84EA-A20A157E0E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4FEB64D-19F5-08BE-EAEF-87DF709C1C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307549D-ABA3-EB08-8290-44E3B04E86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CBED87E-53CF-DEF2-DCD3-80E2DE3CF0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98933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29E8176-966B-00DC-47EF-80D1A9F53F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8F2C4EF-7CF5-65C5-ECA5-79D17119B7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2CC36BA-FB16-683C-862E-29F5F70829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A3D69E1-81B7-BDFA-471C-A237BE47DE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872E425-3DF6-E4E1-CF4F-01D76A2AA2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2490298-196B-F248-42A0-31A06A7C94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0958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415912B-9EB8-A6D9-430A-074890A918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27711D1-44E9-ACD2-996B-FEAACEDB2E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1574325-69CA-AC0A-B752-311A35A39A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0B8EB0C-0AEE-1577-72A6-FD080455F1F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231AAA8-FD7D-BCDD-16B4-24F9F37929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11E3ABF-20BD-CD53-ED40-F4E92255C6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EF2AC9D-B694-C637-4096-383B889E31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4287BCBB-6053-DAF6-2F9C-133E49C165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1098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EE92910-1DEB-DF57-99D2-269E69BDBB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CC3186B7-007E-5664-5002-BA742C6A34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1975313-6A14-36F6-2637-CAEE52EABF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C795A2A-0464-7A95-F016-018C8C07F5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01907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AD31F1F0-3983-57BD-2019-A9FA64A92B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ECA3F45-BFDC-C997-7C5F-096D07C417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47D842F-D802-6E74-102E-932E2489FB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99447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DA8639-4CCA-D974-9CD5-B707C245A7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614FE5A-DEAD-053C-5C0D-D5AD817772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87B511F-8209-5F5B-BE99-5C037D5F4D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83B58B4-4BCC-BE4B-BAF5-28152A33A9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0C01102-C8F0-117D-8D40-A7D3AFBC47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4DED17E-2CD0-AE71-99A0-C44091ACE0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4383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F334AEB-83A9-33DF-0078-3ADFF9CE3A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20EE52E-E90B-561A-0BD6-932FBEF63F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41153CF-B0F9-6EDE-3D79-D827745D7F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D5CB949-6EB0-0C73-598D-0BF1D14B61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0106B57-279C-DC9B-138A-79C2755708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811062D-AC7B-41E2-BA17-62C67C80C6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30259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3EF9513-5A52-1EE3-9387-48A0DBF139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52F3A20-4EBC-4306-0981-7A43D4C29A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67C7209-ACFD-1433-A499-8D0198D20AB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7B22CF8-3547-B503-50A9-AF94430923E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6EBC64B-F869-48AF-3263-860E06C47C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08969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DB4C5AD-5FFA-3319-6444-C330C2B7D7E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3" name="テキスト ボックス 202">
            <a:extLst>
              <a:ext uri="{FF2B5EF4-FFF2-40B4-BE49-F238E27FC236}">
                <a16:creationId xmlns:a16="http://schemas.microsoft.com/office/drawing/2014/main" id="{19A7BA5B-14E9-39EA-4A81-1060EE185129}"/>
              </a:ext>
            </a:extLst>
          </p:cNvPr>
          <p:cNvSpPr txBox="1"/>
          <p:nvPr/>
        </p:nvSpPr>
        <p:spPr>
          <a:xfrm>
            <a:off x="0" y="5513390"/>
            <a:ext cx="1219200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  </a:t>
            </a:r>
            <a:r>
              <a:rPr lang="en-US" altLang="ja-JP" sz="16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aplan-Meier curves for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gression free survival (PFS)</a:t>
            </a:r>
            <a:r>
              <a:rPr lang="en-US" altLang="ja-JP" sz="16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 </a:t>
            </a:r>
            <a:r>
              <a:rPr lang="en-US" altLang="ja-JP" sz="1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median PFS stratified by the optimal value of </a:t>
            </a:r>
            <a:r>
              <a:rPr lang="en-US" altLang="ja-JP" sz="16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Δlymphocyte</a:t>
            </a:r>
            <a:r>
              <a:rPr lang="en-US" altLang="ja-JP" sz="1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+245/µL) at 2 weeks after durvalumab plus </a:t>
            </a:r>
            <a:r>
              <a:rPr lang="en-US" altLang="ja-JP" sz="16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remelimumab</a:t>
            </a:r>
            <a:r>
              <a:rPr lang="en-US" altLang="ja-JP" sz="1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introduction. The median PFS in the high </a:t>
            </a:r>
            <a:r>
              <a:rPr lang="en-US" altLang="ja-JP" sz="16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Δlymphocyte</a:t>
            </a:r>
            <a:r>
              <a:rPr lang="en-US" altLang="ja-JP" sz="1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group (n = 9) (solid line) was significantly better than that in the low </a:t>
            </a:r>
            <a:r>
              <a:rPr lang="en-US" altLang="ja-JP" sz="16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Δlymphocyte</a:t>
            </a:r>
            <a:r>
              <a:rPr lang="en-US" altLang="ja-JP" sz="1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group (n = 20) (dotted line). </a:t>
            </a:r>
            <a:r>
              <a:rPr lang="en-US" altLang="ja-JP" sz="160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bbreviations: PFS, </a:t>
            </a:r>
            <a:r>
              <a:rPr lang="en-US" altLang="ja-JP" sz="1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rogression‐free survival; </a:t>
            </a:r>
            <a:r>
              <a:rPr lang="en-US" altLang="ja-JP" sz="16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Δlymphocyte</a:t>
            </a:r>
            <a:r>
              <a:rPr lang="en-US" altLang="ja-JP" sz="1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ja-JP" sz="1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 change of the amount of lymphocyte count between at baseline and at 2 weeks after d</a:t>
            </a:r>
            <a:r>
              <a:rPr lang="en-US" altLang="ja-JP" sz="1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urvalumab plus </a:t>
            </a:r>
            <a:r>
              <a:rPr lang="en-US" altLang="ja-JP" sz="16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</a:t>
            </a:r>
            <a:r>
              <a:rPr lang="en-US" altLang="ja-JP" sz="16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emelimumab</a:t>
            </a:r>
            <a:r>
              <a:rPr lang="en-US" altLang="ja-JP" sz="1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introduction</a:t>
            </a:r>
            <a:r>
              <a:rPr lang="en-US" altLang="ja-JP" sz="1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;</a:t>
            </a:r>
            <a:r>
              <a:rPr lang="en-US" altLang="ja-JP" sz="160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I, </a:t>
            </a:r>
            <a:r>
              <a:rPr lang="en-US" altLang="ja-JP" sz="1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onfidence interval.</a:t>
            </a:r>
            <a:endParaRPr lang="ja-JP" altLang="ja-JP" sz="16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48" name="Line 8">
            <a:extLst>
              <a:ext uri="{FF2B5EF4-FFF2-40B4-BE49-F238E27FC236}">
                <a16:creationId xmlns:a16="http://schemas.microsoft.com/office/drawing/2014/main" id="{3086C933-2B00-3666-4E9D-DF01B1A4A9A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436117" y="4275373"/>
            <a:ext cx="0" cy="97542"/>
          </a:xfrm>
          <a:prstGeom prst="line">
            <a:avLst/>
          </a:prstGeom>
          <a:noFill/>
          <a:ln w="1905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9" name="Line 9">
            <a:extLst>
              <a:ext uri="{FF2B5EF4-FFF2-40B4-BE49-F238E27FC236}">
                <a16:creationId xmlns:a16="http://schemas.microsoft.com/office/drawing/2014/main" id="{82B39428-D35C-8F3E-D730-D13DED339354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883472" y="4275373"/>
            <a:ext cx="0" cy="97542"/>
          </a:xfrm>
          <a:prstGeom prst="line">
            <a:avLst/>
          </a:prstGeom>
          <a:noFill/>
          <a:ln w="1905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0" name="Line 10">
            <a:extLst>
              <a:ext uri="{FF2B5EF4-FFF2-40B4-BE49-F238E27FC236}">
                <a16:creationId xmlns:a16="http://schemas.microsoft.com/office/drawing/2014/main" id="{2B673AC8-9F62-60AA-26A3-0649B4D0F606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330826" y="4275373"/>
            <a:ext cx="0" cy="97542"/>
          </a:xfrm>
          <a:prstGeom prst="line">
            <a:avLst/>
          </a:prstGeom>
          <a:noFill/>
          <a:ln w="1905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1" name="Line 11">
            <a:extLst>
              <a:ext uri="{FF2B5EF4-FFF2-40B4-BE49-F238E27FC236}">
                <a16:creationId xmlns:a16="http://schemas.microsoft.com/office/drawing/2014/main" id="{3F394DF1-9A85-ABD0-7C39-53872AEE1BE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778181" y="4275373"/>
            <a:ext cx="0" cy="97542"/>
          </a:xfrm>
          <a:prstGeom prst="line">
            <a:avLst/>
          </a:prstGeom>
          <a:noFill/>
          <a:ln w="1905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Line 12">
            <a:extLst>
              <a:ext uri="{FF2B5EF4-FFF2-40B4-BE49-F238E27FC236}">
                <a16:creationId xmlns:a16="http://schemas.microsoft.com/office/drawing/2014/main" id="{06ED7EF6-3AA4-D105-A10D-40891F3E00F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225535" y="4275373"/>
            <a:ext cx="0" cy="97542"/>
          </a:xfrm>
          <a:prstGeom prst="line">
            <a:avLst/>
          </a:prstGeom>
          <a:noFill/>
          <a:ln w="1905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Line 13">
            <a:extLst>
              <a:ext uri="{FF2B5EF4-FFF2-40B4-BE49-F238E27FC236}">
                <a16:creationId xmlns:a16="http://schemas.microsoft.com/office/drawing/2014/main" id="{BFDCF0BF-E38F-0100-566B-982305261763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672889" y="4275373"/>
            <a:ext cx="0" cy="97542"/>
          </a:xfrm>
          <a:prstGeom prst="line">
            <a:avLst/>
          </a:prstGeom>
          <a:noFill/>
          <a:ln w="1905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Line 14">
            <a:extLst>
              <a:ext uri="{FF2B5EF4-FFF2-40B4-BE49-F238E27FC236}">
                <a16:creationId xmlns:a16="http://schemas.microsoft.com/office/drawing/2014/main" id="{54C94CC0-16E3-42D5-D4E4-8D6663925B16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120243" y="4275373"/>
            <a:ext cx="0" cy="97542"/>
          </a:xfrm>
          <a:prstGeom prst="line">
            <a:avLst/>
          </a:prstGeom>
          <a:noFill/>
          <a:ln w="1905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5" name="Line 15">
            <a:extLst>
              <a:ext uri="{FF2B5EF4-FFF2-40B4-BE49-F238E27FC236}">
                <a16:creationId xmlns:a16="http://schemas.microsoft.com/office/drawing/2014/main" id="{3625E5C0-F1D8-DDC4-1F1E-D79FCE62BA83}"/>
              </a:ext>
            </a:extLst>
          </p:cNvPr>
          <p:cNvSpPr>
            <a:spLocks noChangeShapeType="1"/>
          </p:cNvSpPr>
          <p:nvPr/>
        </p:nvSpPr>
        <p:spPr bwMode="auto">
          <a:xfrm>
            <a:off x="1168615" y="4185991"/>
            <a:ext cx="94763" cy="0"/>
          </a:xfrm>
          <a:prstGeom prst="line">
            <a:avLst/>
          </a:prstGeom>
          <a:noFill/>
          <a:ln w="1905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Line 16">
            <a:extLst>
              <a:ext uri="{FF2B5EF4-FFF2-40B4-BE49-F238E27FC236}">
                <a16:creationId xmlns:a16="http://schemas.microsoft.com/office/drawing/2014/main" id="{1DCA0A2B-4A40-B5B1-086B-9C9BC15BE401}"/>
              </a:ext>
            </a:extLst>
          </p:cNvPr>
          <p:cNvSpPr>
            <a:spLocks noChangeShapeType="1"/>
          </p:cNvSpPr>
          <p:nvPr/>
        </p:nvSpPr>
        <p:spPr bwMode="auto">
          <a:xfrm>
            <a:off x="1168615" y="3533618"/>
            <a:ext cx="94763" cy="0"/>
          </a:xfrm>
          <a:prstGeom prst="line">
            <a:avLst/>
          </a:prstGeom>
          <a:noFill/>
          <a:ln w="1905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7" name="Line 17">
            <a:extLst>
              <a:ext uri="{FF2B5EF4-FFF2-40B4-BE49-F238E27FC236}">
                <a16:creationId xmlns:a16="http://schemas.microsoft.com/office/drawing/2014/main" id="{155701B7-6688-5750-1D53-BE415BD2B7C3}"/>
              </a:ext>
            </a:extLst>
          </p:cNvPr>
          <p:cNvSpPr>
            <a:spLocks noChangeShapeType="1"/>
          </p:cNvSpPr>
          <p:nvPr/>
        </p:nvSpPr>
        <p:spPr bwMode="auto">
          <a:xfrm>
            <a:off x="1168615" y="2879813"/>
            <a:ext cx="94763" cy="0"/>
          </a:xfrm>
          <a:prstGeom prst="line">
            <a:avLst/>
          </a:prstGeom>
          <a:noFill/>
          <a:ln w="1905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8" name="Line 18">
            <a:extLst>
              <a:ext uri="{FF2B5EF4-FFF2-40B4-BE49-F238E27FC236}">
                <a16:creationId xmlns:a16="http://schemas.microsoft.com/office/drawing/2014/main" id="{2035D32D-ED7F-CD90-D2C7-72039228FFF7}"/>
              </a:ext>
            </a:extLst>
          </p:cNvPr>
          <p:cNvSpPr>
            <a:spLocks noChangeShapeType="1"/>
          </p:cNvSpPr>
          <p:nvPr/>
        </p:nvSpPr>
        <p:spPr bwMode="auto">
          <a:xfrm>
            <a:off x="1168615" y="2227442"/>
            <a:ext cx="94763" cy="0"/>
          </a:xfrm>
          <a:prstGeom prst="line">
            <a:avLst/>
          </a:prstGeom>
          <a:noFill/>
          <a:ln w="1905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9" name="Line 19">
            <a:extLst>
              <a:ext uri="{FF2B5EF4-FFF2-40B4-BE49-F238E27FC236}">
                <a16:creationId xmlns:a16="http://schemas.microsoft.com/office/drawing/2014/main" id="{B2EF75B0-AF89-0A4C-5E50-F04D5C3D7C12}"/>
              </a:ext>
            </a:extLst>
          </p:cNvPr>
          <p:cNvSpPr>
            <a:spLocks noChangeShapeType="1"/>
          </p:cNvSpPr>
          <p:nvPr/>
        </p:nvSpPr>
        <p:spPr bwMode="auto">
          <a:xfrm>
            <a:off x="1168615" y="1575070"/>
            <a:ext cx="94763" cy="0"/>
          </a:xfrm>
          <a:prstGeom prst="line">
            <a:avLst/>
          </a:prstGeom>
          <a:noFill/>
          <a:ln w="1905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Line 20">
            <a:extLst>
              <a:ext uri="{FF2B5EF4-FFF2-40B4-BE49-F238E27FC236}">
                <a16:creationId xmlns:a16="http://schemas.microsoft.com/office/drawing/2014/main" id="{BF050C98-2B5B-FC76-60BF-21114FAD8B7C}"/>
              </a:ext>
            </a:extLst>
          </p:cNvPr>
          <p:cNvSpPr>
            <a:spLocks noChangeShapeType="1"/>
          </p:cNvSpPr>
          <p:nvPr/>
        </p:nvSpPr>
        <p:spPr bwMode="auto">
          <a:xfrm>
            <a:off x="1168615" y="922698"/>
            <a:ext cx="94763" cy="0"/>
          </a:xfrm>
          <a:prstGeom prst="line">
            <a:avLst/>
          </a:prstGeom>
          <a:noFill/>
          <a:ln w="1905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Line 21">
            <a:extLst>
              <a:ext uri="{FF2B5EF4-FFF2-40B4-BE49-F238E27FC236}">
                <a16:creationId xmlns:a16="http://schemas.microsoft.com/office/drawing/2014/main" id="{726F3A09-B4DF-C736-2B9C-A60221F87E5F}"/>
              </a:ext>
            </a:extLst>
          </p:cNvPr>
          <p:cNvSpPr>
            <a:spLocks noChangeShapeType="1"/>
          </p:cNvSpPr>
          <p:nvPr/>
        </p:nvSpPr>
        <p:spPr bwMode="auto">
          <a:xfrm>
            <a:off x="1168615" y="4368082"/>
            <a:ext cx="4982506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2" name="Rectangle 24">
            <a:extLst>
              <a:ext uri="{FF2B5EF4-FFF2-40B4-BE49-F238E27FC236}">
                <a16:creationId xmlns:a16="http://schemas.microsoft.com/office/drawing/2014/main" id="{BE1D91FF-685C-01C1-B849-FC3FF934BB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50903" y="4411074"/>
            <a:ext cx="135235" cy="1665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2</a:t>
            </a:r>
            <a:endParaRPr kumimoji="1" lang="ja-JP" altLang="ja-JP" sz="2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63" name="Rectangle 25">
            <a:extLst>
              <a:ext uri="{FF2B5EF4-FFF2-40B4-BE49-F238E27FC236}">
                <a16:creationId xmlns:a16="http://schemas.microsoft.com/office/drawing/2014/main" id="{AA931DCD-C00F-EEAB-74F7-9CDE7E6C5E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05508" y="4411074"/>
            <a:ext cx="135235" cy="1665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0</a:t>
            </a:r>
            <a:endParaRPr kumimoji="1" lang="ja-JP" altLang="ja-JP" sz="2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64" name="Rectangle 26">
            <a:extLst>
              <a:ext uri="{FF2B5EF4-FFF2-40B4-BE49-F238E27FC236}">
                <a16:creationId xmlns:a16="http://schemas.microsoft.com/office/drawing/2014/main" id="{6208ABB3-D495-816B-3F62-AB55EF01070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93066" y="4411074"/>
            <a:ext cx="67618" cy="1665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8</a:t>
            </a:r>
            <a:endParaRPr kumimoji="1" lang="ja-JP" altLang="ja-JP" sz="2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65" name="Rectangle 27">
            <a:extLst>
              <a:ext uri="{FF2B5EF4-FFF2-40B4-BE49-F238E27FC236}">
                <a16:creationId xmlns:a16="http://schemas.microsoft.com/office/drawing/2014/main" id="{4CF54D6B-8280-E0EB-1D82-D92B54A4480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45419" y="4411074"/>
            <a:ext cx="67618" cy="1665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6</a:t>
            </a:r>
            <a:endParaRPr kumimoji="1" lang="ja-JP" altLang="ja-JP" sz="2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66" name="Rectangle 28">
            <a:extLst>
              <a:ext uri="{FF2B5EF4-FFF2-40B4-BE49-F238E27FC236}">
                <a16:creationId xmlns:a16="http://schemas.microsoft.com/office/drawing/2014/main" id="{E2439B41-E1A3-564A-3BCE-656FC47DE9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94821" y="4411074"/>
            <a:ext cx="67618" cy="1665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4</a:t>
            </a:r>
            <a:endParaRPr kumimoji="1" lang="ja-JP" altLang="ja-JP" sz="2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67" name="Rectangle 29">
            <a:extLst>
              <a:ext uri="{FF2B5EF4-FFF2-40B4-BE49-F238E27FC236}">
                <a16:creationId xmlns:a16="http://schemas.microsoft.com/office/drawing/2014/main" id="{E9432470-07ED-0349-08A1-3A7A484AC7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48050" y="4411074"/>
            <a:ext cx="67618" cy="1665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2</a:t>
            </a:r>
            <a:endParaRPr kumimoji="1" lang="ja-JP" altLang="ja-JP" sz="2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68" name="Rectangle 30">
            <a:extLst>
              <a:ext uri="{FF2B5EF4-FFF2-40B4-BE49-F238E27FC236}">
                <a16:creationId xmlns:a16="http://schemas.microsoft.com/office/drawing/2014/main" id="{FF7AEC3F-51FC-3B68-03B7-393FC4A261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06235" y="4411074"/>
            <a:ext cx="67618" cy="1665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0</a:t>
            </a:r>
            <a:endParaRPr kumimoji="1" lang="ja-JP" altLang="ja-JP" sz="2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69" name="Line 31">
            <a:extLst>
              <a:ext uri="{FF2B5EF4-FFF2-40B4-BE49-F238E27FC236}">
                <a16:creationId xmlns:a16="http://schemas.microsoft.com/office/drawing/2014/main" id="{183815E7-74D2-8411-F70A-C5598F0860A8}"/>
              </a:ext>
            </a:extLst>
          </p:cNvPr>
          <p:cNvSpPr>
            <a:spLocks noChangeShapeType="1"/>
          </p:cNvSpPr>
          <p:nvPr/>
        </p:nvSpPr>
        <p:spPr bwMode="auto">
          <a:xfrm>
            <a:off x="1168615" y="750131"/>
            <a:ext cx="0" cy="3627476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0" name="Rectangle 36">
            <a:extLst>
              <a:ext uri="{FF2B5EF4-FFF2-40B4-BE49-F238E27FC236}">
                <a16:creationId xmlns:a16="http://schemas.microsoft.com/office/drawing/2014/main" id="{51DAD435-E8C4-3C48-5D7B-926A8ABD52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0772" y="832093"/>
            <a:ext cx="202853" cy="1665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0</a:t>
            </a:r>
            <a:r>
              <a:rPr kumimoji="1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0</a:t>
            </a:r>
            <a:endParaRPr kumimoji="1" lang="ja-JP" altLang="ja-JP" sz="2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71" name="Rectangle 37">
            <a:extLst>
              <a:ext uri="{FF2B5EF4-FFF2-40B4-BE49-F238E27FC236}">
                <a16:creationId xmlns:a16="http://schemas.microsoft.com/office/drawing/2014/main" id="{36F5C9F9-31E8-48AB-45A7-A720059983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8132" y="1487948"/>
            <a:ext cx="135235" cy="1665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8</a:t>
            </a:r>
            <a:r>
              <a:rPr kumimoji="1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0</a:t>
            </a:r>
            <a:endParaRPr kumimoji="1" lang="ja-JP" altLang="ja-JP" sz="2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72" name="Rectangle 38">
            <a:extLst>
              <a:ext uri="{FF2B5EF4-FFF2-40B4-BE49-F238E27FC236}">
                <a16:creationId xmlns:a16="http://schemas.microsoft.com/office/drawing/2014/main" id="{0B858275-DCA0-914B-AA8D-679DA5295E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8132" y="2142881"/>
            <a:ext cx="135235" cy="1665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6</a:t>
            </a:r>
            <a:r>
              <a:rPr kumimoji="1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0</a:t>
            </a:r>
            <a:endParaRPr kumimoji="1" lang="ja-JP" altLang="ja-JP" sz="2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73" name="Rectangle 39">
            <a:extLst>
              <a:ext uri="{FF2B5EF4-FFF2-40B4-BE49-F238E27FC236}">
                <a16:creationId xmlns:a16="http://schemas.microsoft.com/office/drawing/2014/main" id="{C4F5C85C-4F16-57CB-239E-D5B838F17B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8132" y="2789210"/>
            <a:ext cx="135235" cy="1665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4</a:t>
            </a:r>
            <a:r>
              <a:rPr kumimoji="1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0</a:t>
            </a:r>
            <a:endParaRPr kumimoji="1" lang="ja-JP" altLang="ja-JP" sz="2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74" name="Rectangle 40">
            <a:extLst>
              <a:ext uri="{FF2B5EF4-FFF2-40B4-BE49-F238E27FC236}">
                <a16:creationId xmlns:a16="http://schemas.microsoft.com/office/drawing/2014/main" id="{A9E0419E-CB3F-BD14-D128-9063696043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8132" y="3445063"/>
            <a:ext cx="135235" cy="1665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2</a:t>
            </a:r>
            <a:r>
              <a:rPr kumimoji="1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0</a:t>
            </a:r>
            <a:endParaRPr kumimoji="1" lang="ja-JP" altLang="ja-JP" sz="2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75" name="Rectangle 41">
            <a:extLst>
              <a:ext uri="{FF2B5EF4-FFF2-40B4-BE49-F238E27FC236}">
                <a16:creationId xmlns:a16="http://schemas.microsoft.com/office/drawing/2014/main" id="{462DF816-A7FE-BC97-D567-B6B63E62C2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15490" y="4096822"/>
            <a:ext cx="67618" cy="1665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0</a:t>
            </a:r>
            <a:endParaRPr kumimoji="1" lang="ja-JP" altLang="ja-JP" sz="2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77" name="テキスト ボックス 176">
            <a:extLst>
              <a:ext uri="{FF2B5EF4-FFF2-40B4-BE49-F238E27FC236}">
                <a16:creationId xmlns:a16="http://schemas.microsoft.com/office/drawing/2014/main" id="{D4887138-54F4-6135-3424-7767884451E5}"/>
              </a:ext>
            </a:extLst>
          </p:cNvPr>
          <p:cNvSpPr txBox="1"/>
          <p:nvPr/>
        </p:nvSpPr>
        <p:spPr>
          <a:xfrm rot="16200000">
            <a:off x="218040" y="2397946"/>
            <a:ext cx="8451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F</a:t>
            </a:r>
            <a:r>
              <a:rPr kumimoji="1" lang="en-US" altLang="ja-JP" sz="14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 (%)</a:t>
            </a:r>
            <a:endParaRPr kumimoji="1" lang="ja-JP" altLang="en-US" sz="1400" b="1" dirty="0"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78" name="テキスト ボックス 177">
            <a:extLst>
              <a:ext uri="{FF2B5EF4-FFF2-40B4-BE49-F238E27FC236}">
                <a16:creationId xmlns:a16="http://schemas.microsoft.com/office/drawing/2014/main" id="{CCCDF459-B339-A2BC-63FF-EB5B842380C2}"/>
              </a:ext>
            </a:extLst>
          </p:cNvPr>
          <p:cNvSpPr txBox="1"/>
          <p:nvPr/>
        </p:nvSpPr>
        <p:spPr>
          <a:xfrm>
            <a:off x="1155903" y="4742242"/>
            <a:ext cx="1045934" cy="2498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Number at risk</a:t>
            </a:r>
            <a:endParaRPr kumimoji="1" lang="ja-JP" altLang="en-US" sz="1200" b="1" dirty="0"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79" name="Rectangle 26">
            <a:extLst>
              <a:ext uri="{FF2B5EF4-FFF2-40B4-BE49-F238E27FC236}">
                <a16:creationId xmlns:a16="http://schemas.microsoft.com/office/drawing/2014/main" id="{68455341-8412-9576-D076-6E2ECAC089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03907" y="5012199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9</a:t>
            </a:r>
            <a:endParaRPr kumimoji="1" lang="ja-JP" altLang="ja-JP" sz="2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80" name="Rectangle 26">
            <a:extLst>
              <a:ext uri="{FF2B5EF4-FFF2-40B4-BE49-F238E27FC236}">
                <a16:creationId xmlns:a16="http://schemas.microsoft.com/office/drawing/2014/main" id="{C92FD837-0855-61D1-923C-481DD25FA3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43641" y="5012199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8</a:t>
            </a:r>
            <a:endParaRPr kumimoji="1" lang="ja-JP" altLang="ja-JP" sz="2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81" name="Rectangle 26">
            <a:extLst>
              <a:ext uri="{FF2B5EF4-FFF2-40B4-BE49-F238E27FC236}">
                <a16:creationId xmlns:a16="http://schemas.microsoft.com/office/drawing/2014/main" id="{52C051D3-E8B4-9685-3DA9-6A832E6DA9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41694" y="5012199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5</a:t>
            </a:r>
            <a:endParaRPr kumimoji="1" lang="ja-JP" altLang="ja-JP" sz="2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82" name="Rectangle 26">
            <a:extLst>
              <a:ext uri="{FF2B5EF4-FFF2-40B4-BE49-F238E27FC236}">
                <a16:creationId xmlns:a16="http://schemas.microsoft.com/office/drawing/2014/main" id="{AC8403CC-B26A-A07E-B008-E000AEE8CC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34249" y="5012199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4</a:t>
            </a:r>
            <a:endParaRPr kumimoji="1" lang="ja-JP" altLang="ja-JP" sz="2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83" name="テキスト ボックス 182">
            <a:extLst>
              <a:ext uri="{FF2B5EF4-FFF2-40B4-BE49-F238E27FC236}">
                <a16:creationId xmlns:a16="http://schemas.microsoft.com/office/drawing/2014/main" id="{2B8A3C50-513D-8E27-61FC-5C6422F70ABC}"/>
              </a:ext>
            </a:extLst>
          </p:cNvPr>
          <p:cNvSpPr txBox="1"/>
          <p:nvPr/>
        </p:nvSpPr>
        <p:spPr>
          <a:xfrm>
            <a:off x="2614954" y="4574297"/>
            <a:ext cx="21311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Observation period (months)</a:t>
            </a:r>
            <a:endParaRPr kumimoji="1" lang="ja-JP" altLang="en-US" sz="1200" b="1" dirty="0"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84" name="Rectangle 26">
            <a:extLst>
              <a:ext uri="{FF2B5EF4-FFF2-40B4-BE49-F238E27FC236}">
                <a16:creationId xmlns:a16="http://schemas.microsoft.com/office/drawing/2014/main" id="{715B0124-AF23-1F79-2588-30392A1805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85198" y="5012199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7</a:t>
            </a:r>
            <a:endParaRPr kumimoji="1" lang="ja-JP" altLang="ja-JP" sz="2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85" name="Rectangle 26">
            <a:extLst>
              <a:ext uri="{FF2B5EF4-FFF2-40B4-BE49-F238E27FC236}">
                <a16:creationId xmlns:a16="http://schemas.microsoft.com/office/drawing/2014/main" id="{921AB3BD-05B2-2E87-1FBC-F6F03981F8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89717" y="5012199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4</a:t>
            </a:r>
            <a:endParaRPr kumimoji="1" lang="ja-JP" altLang="ja-JP" sz="2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86" name="Rectangle 26">
            <a:extLst>
              <a:ext uri="{FF2B5EF4-FFF2-40B4-BE49-F238E27FC236}">
                <a16:creationId xmlns:a16="http://schemas.microsoft.com/office/drawing/2014/main" id="{A9E2309D-EE62-B7C4-F13A-7641DC902B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79297" y="5012199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4</a:t>
            </a:r>
            <a:endParaRPr kumimoji="1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87" name="Line 14">
            <a:extLst>
              <a:ext uri="{FF2B5EF4-FFF2-40B4-BE49-F238E27FC236}">
                <a16:creationId xmlns:a16="http://schemas.microsoft.com/office/drawing/2014/main" id="{223CBCFC-E3BC-13E9-751F-8FDFF87244A4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567598" y="4275373"/>
            <a:ext cx="0" cy="97542"/>
          </a:xfrm>
          <a:prstGeom prst="line">
            <a:avLst/>
          </a:prstGeom>
          <a:noFill/>
          <a:ln w="1905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8" name="Rectangle 24">
            <a:extLst>
              <a:ext uri="{FF2B5EF4-FFF2-40B4-BE49-F238E27FC236}">
                <a16:creationId xmlns:a16="http://schemas.microsoft.com/office/drawing/2014/main" id="{786FC425-3038-1E1C-86FB-DD167B6E49B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01928" y="4411074"/>
            <a:ext cx="135235" cy="1665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4</a:t>
            </a:r>
            <a:endParaRPr kumimoji="1" lang="ja-JP" altLang="ja-JP" sz="2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89" name="Line 14">
            <a:extLst>
              <a:ext uri="{FF2B5EF4-FFF2-40B4-BE49-F238E27FC236}">
                <a16:creationId xmlns:a16="http://schemas.microsoft.com/office/drawing/2014/main" id="{A04F294E-3063-B1AC-EB9D-71D657EE7753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014952" y="4275373"/>
            <a:ext cx="0" cy="97542"/>
          </a:xfrm>
          <a:prstGeom prst="line">
            <a:avLst/>
          </a:prstGeom>
          <a:noFill/>
          <a:ln w="1905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0" name="Rectangle 24">
            <a:extLst>
              <a:ext uri="{FF2B5EF4-FFF2-40B4-BE49-F238E27FC236}">
                <a16:creationId xmlns:a16="http://schemas.microsoft.com/office/drawing/2014/main" id="{C3AE7612-0E2F-5ABA-8369-76C66CAF67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44770" y="4411074"/>
            <a:ext cx="135235" cy="1665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6</a:t>
            </a:r>
            <a:endParaRPr kumimoji="1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91" name="Line 14">
            <a:extLst>
              <a:ext uri="{FF2B5EF4-FFF2-40B4-BE49-F238E27FC236}">
                <a16:creationId xmlns:a16="http://schemas.microsoft.com/office/drawing/2014/main" id="{45FD93DA-4518-9DE8-879D-BD83EDD9E75F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462307" y="4275373"/>
            <a:ext cx="0" cy="97542"/>
          </a:xfrm>
          <a:prstGeom prst="line">
            <a:avLst/>
          </a:prstGeom>
          <a:noFill/>
          <a:ln w="1905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2" name="Rectangle 24">
            <a:extLst>
              <a:ext uri="{FF2B5EF4-FFF2-40B4-BE49-F238E27FC236}">
                <a16:creationId xmlns:a16="http://schemas.microsoft.com/office/drawing/2014/main" id="{2354E9C4-2305-9691-185E-D954E37FB7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94426" y="4411074"/>
            <a:ext cx="135235" cy="1665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8</a:t>
            </a:r>
            <a:endParaRPr kumimoji="1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93" name="Line 14">
            <a:extLst>
              <a:ext uri="{FF2B5EF4-FFF2-40B4-BE49-F238E27FC236}">
                <a16:creationId xmlns:a16="http://schemas.microsoft.com/office/drawing/2014/main" id="{A367CBB4-EFED-D478-6316-F01E05141F0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909657" y="4275373"/>
            <a:ext cx="0" cy="97542"/>
          </a:xfrm>
          <a:prstGeom prst="line">
            <a:avLst/>
          </a:prstGeom>
          <a:noFill/>
          <a:ln w="1905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4" name="Rectangle 24">
            <a:extLst>
              <a:ext uri="{FF2B5EF4-FFF2-40B4-BE49-F238E27FC236}">
                <a16:creationId xmlns:a16="http://schemas.microsoft.com/office/drawing/2014/main" id="{A456D768-1407-ECD0-4A4B-0689DD11A7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45171" y="4411074"/>
            <a:ext cx="135235" cy="1665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20</a:t>
            </a:r>
            <a:endParaRPr kumimoji="1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95" name="Rectangle 26">
            <a:extLst>
              <a:ext uri="{FF2B5EF4-FFF2-40B4-BE49-F238E27FC236}">
                <a16:creationId xmlns:a16="http://schemas.microsoft.com/office/drawing/2014/main" id="{D63A7D4A-C4C1-1A24-F07B-9CD9DFF9F92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34861" y="5012199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3</a:t>
            </a:r>
            <a:endParaRPr kumimoji="1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96" name="Rectangle 26">
            <a:extLst>
              <a:ext uri="{FF2B5EF4-FFF2-40B4-BE49-F238E27FC236}">
                <a16:creationId xmlns:a16="http://schemas.microsoft.com/office/drawing/2014/main" id="{5D8D6CF6-C466-00FE-62F0-BA2864C9AA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75255" y="5012199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1</a:t>
            </a:r>
            <a:endParaRPr kumimoji="1" lang="ja-JP" altLang="ja-JP" sz="2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97" name="Rectangle 26">
            <a:extLst>
              <a:ext uri="{FF2B5EF4-FFF2-40B4-BE49-F238E27FC236}">
                <a16:creationId xmlns:a16="http://schemas.microsoft.com/office/drawing/2014/main" id="{C80081D2-FE29-6BAA-2304-24111A667C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25292" y="5012199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1</a:t>
            </a:r>
            <a:endParaRPr kumimoji="1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98" name="Rectangle 26">
            <a:extLst>
              <a:ext uri="{FF2B5EF4-FFF2-40B4-BE49-F238E27FC236}">
                <a16:creationId xmlns:a16="http://schemas.microsoft.com/office/drawing/2014/main" id="{55D1FE86-693C-7EAB-E121-3D6923AF0EF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71132" y="5235993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20</a:t>
            </a:r>
            <a:endParaRPr kumimoji="1" lang="ja-JP" altLang="ja-JP" sz="2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99" name="Rectangle 26">
            <a:extLst>
              <a:ext uri="{FF2B5EF4-FFF2-40B4-BE49-F238E27FC236}">
                <a16:creationId xmlns:a16="http://schemas.microsoft.com/office/drawing/2014/main" id="{266474C1-ACF0-E862-A55A-69D30B7904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04849" y="5235993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10</a:t>
            </a:r>
            <a:endParaRPr kumimoji="1" lang="ja-JP" altLang="ja-JP" sz="2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200" name="Rectangle 26">
            <a:extLst>
              <a:ext uri="{FF2B5EF4-FFF2-40B4-BE49-F238E27FC236}">
                <a16:creationId xmlns:a16="http://schemas.microsoft.com/office/drawing/2014/main" id="{EA5588E9-D1C4-CEAC-EC65-11CA74BB31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89821" y="5235993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5</a:t>
            </a:r>
            <a:endParaRPr kumimoji="1" lang="ja-JP" altLang="ja-JP" sz="2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201" name="Rectangle 71">
            <a:extLst>
              <a:ext uri="{FF2B5EF4-FFF2-40B4-BE49-F238E27FC236}">
                <a16:creationId xmlns:a16="http://schemas.microsoft.com/office/drawing/2014/main" id="{2F2ED05B-2E17-0994-25DC-282066F834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6078" y="5012199"/>
            <a:ext cx="107240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b="1" dirty="0" err="1"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Δlympho</a:t>
            </a:r>
            <a:r>
              <a:rPr lang="en-US" altLang="ja-JP" sz="1200" b="1" dirty="0"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ja-JP" sz="12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≥</a:t>
            </a:r>
            <a:r>
              <a:rPr lang="en-US" altLang="ja-JP" sz="1200" b="1" dirty="0"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+245</a:t>
            </a:r>
            <a:endParaRPr kumimoji="1" lang="ja-JP" altLang="ja-JP" sz="1200" b="1" i="0" u="none" strike="noStrike" cap="none" normalizeH="0" baseline="0" dirty="0">
              <a:ln>
                <a:noFill/>
              </a:ln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202" name="Rectangle 76">
            <a:extLst>
              <a:ext uri="{FF2B5EF4-FFF2-40B4-BE49-F238E27FC236}">
                <a16:creationId xmlns:a16="http://schemas.microsoft.com/office/drawing/2014/main" id="{DAC4017E-253D-25AE-518C-9EE55D685F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4881" y="5235993"/>
            <a:ext cx="107561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lvl="0"/>
            <a:r>
              <a:rPr lang="en-US" altLang="ja-JP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Δlympho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+245</a:t>
            </a:r>
            <a:endParaRPr lang="ja-JP" altLang="ja-JP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5BA869E-D2FC-695C-44DD-6183C576CF05}"/>
              </a:ext>
            </a:extLst>
          </p:cNvPr>
          <p:cNvSpPr txBox="1"/>
          <p:nvPr/>
        </p:nvSpPr>
        <p:spPr>
          <a:xfrm>
            <a:off x="2980411" y="607313"/>
            <a:ext cx="279457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m</a:t>
            </a:r>
            <a:r>
              <a:rPr kumimoji="1" lang="en-US" altLang="ja-JP" sz="12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edian PFS; months (95% CI)</a:t>
            </a:r>
          </a:p>
          <a:p>
            <a:r>
              <a:rPr lang="en-US" altLang="ja-JP" sz="1200" b="1" dirty="0" err="1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Δlympho</a:t>
            </a:r>
            <a:r>
              <a:rPr lang="en-US" altLang="ja-JP" sz="12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2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≥</a:t>
            </a:r>
            <a:r>
              <a:rPr lang="en-US" altLang="ja-JP" sz="12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+245/µL; 12.92 (0.00</a:t>
            </a:r>
            <a:r>
              <a:rPr lang="en-US" altLang="ja-JP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–</a:t>
            </a:r>
            <a:r>
              <a:rPr lang="en-US" altLang="ja-JP" sz="12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27.72)</a:t>
            </a:r>
          </a:p>
          <a:p>
            <a:r>
              <a:rPr lang="en-US" altLang="ja-JP" sz="1200" b="1" dirty="0" err="1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Δlympho</a:t>
            </a:r>
            <a:r>
              <a:rPr lang="en-US" altLang="ja-JP" sz="12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altLang="ja-JP" sz="12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+245/µL;</a:t>
            </a:r>
            <a:r>
              <a:rPr lang="ja-JP" altLang="en-US" sz="12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2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1.96</a:t>
            </a:r>
            <a:r>
              <a:rPr lang="ja-JP" altLang="en-US" sz="12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2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(0.25</a:t>
            </a:r>
            <a:r>
              <a:rPr lang="en-US" altLang="ja-JP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–</a:t>
            </a:r>
            <a:r>
              <a:rPr lang="en-US" altLang="ja-JP" sz="12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3.67)</a:t>
            </a:r>
            <a:endParaRPr kumimoji="1" lang="en-US" altLang="ja-JP" sz="1200" b="1" dirty="0"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  <a:p>
            <a:r>
              <a:rPr kumimoji="1" lang="en-US" altLang="ja-JP" sz="12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(log-rank </a:t>
            </a:r>
            <a:r>
              <a:rPr kumimoji="1" lang="en-US" altLang="ja-JP" sz="1200" b="1" i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 </a:t>
            </a:r>
            <a:r>
              <a:rPr kumimoji="1" lang="en-US" altLang="ja-JP" sz="12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= 0.008)</a:t>
            </a:r>
          </a:p>
        </p:txBody>
      </p: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AA591E5A-4CE3-E4F4-27FA-3B0948F105D9}"/>
              </a:ext>
            </a:extLst>
          </p:cNvPr>
          <p:cNvCxnSpPr>
            <a:cxnSpLocks/>
          </p:cNvCxnSpPr>
          <p:nvPr/>
        </p:nvCxnSpPr>
        <p:spPr>
          <a:xfrm>
            <a:off x="2506884" y="1134331"/>
            <a:ext cx="473528" cy="0"/>
          </a:xfrm>
          <a:prstGeom prst="line">
            <a:avLst/>
          </a:prstGeom>
          <a:ln w="19050">
            <a:solidFill>
              <a:schemeClr val="accent6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0DC487CF-EF25-C0E9-8F51-E1CBE5CA56E6}"/>
              </a:ext>
            </a:extLst>
          </p:cNvPr>
          <p:cNvCxnSpPr>
            <a:cxnSpLocks/>
          </p:cNvCxnSpPr>
          <p:nvPr/>
        </p:nvCxnSpPr>
        <p:spPr>
          <a:xfrm>
            <a:off x="2506884" y="938389"/>
            <a:ext cx="473528" cy="0"/>
          </a:xfrm>
          <a:prstGeom prst="line">
            <a:avLst/>
          </a:prstGeom>
          <a:ln w="19050">
            <a:solidFill>
              <a:srgbClr val="66003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4" name="Rectangle 26">
            <a:extLst>
              <a:ext uri="{FF2B5EF4-FFF2-40B4-BE49-F238E27FC236}">
                <a16:creationId xmlns:a16="http://schemas.microsoft.com/office/drawing/2014/main" id="{3D8069CB-32C4-5EF3-474F-292CEEB95E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37636" y="5235993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4</a:t>
            </a:r>
            <a:endParaRPr kumimoji="1" lang="ja-JP" altLang="ja-JP" sz="2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55" name="Rectangle 26">
            <a:extLst>
              <a:ext uri="{FF2B5EF4-FFF2-40B4-BE49-F238E27FC236}">
                <a16:creationId xmlns:a16="http://schemas.microsoft.com/office/drawing/2014/main" id="{FD593847-4FF7-3FD0-182F-75382D1FCB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88145" y="5235993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3</a:t>
            </a:r>
            <a:endParaRPr kumimoji="1" lang="ja-JP" altLang="ja-JP" sz="2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56" name="Rectangle 26">
            <a:extLst>
              <a:ext uri="{FF2B5EF4-FFF2-40B4-BE49-F238E27FC236}">
                <a16:creationId xmlns:a16="http://schemas.microsoft.com/office/drawing/2014/main" id="{6A40E57C-9DBE-3039-3C2A-41414C31FD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35041" y="5235993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3</a:t>
            </a:r>
            <a:endParaRPr kumimoji="1" lang="ja-JP" altLang="ja-JP" sz="2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57" name="Rectangle 26">
            <a:extLst>
              <a:ext uri="{FF2B5EF4-FFF2-40B4-BE49-F238E27FC236}">
                <a16:creationId xmlns:a16="http://schemas.microsoft.com/office/drawing/2014/main" id="{D0E02807-4931-8874-1456-945A557805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0562" y="5235993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2</a:t>
            </a:r>
            <a:endParaRPr kumimoji="1" lang="ja-JP" altLang="ja-JP" sz="2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96" name="Rectangle 26">
            <a:extLst>
              <a:ext uri="{FF2B5EF4-FFF2-40B4-BE49-F238E27FC236}">
                <a16:creationId xmlns:a16="http://schemas.microsoft.com/office/drawing/2014/main" id="{6B41458C-6F7D-C6F1-CF66-16AFD879E2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34872" y="5233125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2</a:t>
            </a:r>
            <a:endParaRPr kumimoji="1" lang="ja-JP" altLang="ja-JP" sz="2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grpSp>
        <p:nvGrpSpPr>
          <p:cNvPr id="236" name="グループ化 235">
            <a:extLst>
              <a:ext uri="{FF2B5EF4-FFF2-40B4-BE49-F238E27FC236}">
                <a16:creationId xmlns:a16="http://schemas.microsoft.com/office/drawing/2014/main" id="{05AEF3D2-F9A0-9E72-E325-9F994998F9CB}"/>
              </a:ext>
            </a:extLst>
          </p:cNvPr>
          <p:cNvGrpSpPr/>
          <p:nvPr/>
        </p:nvGrpSpPr>
        <p:grpSpPr>
          <a:xfrm>
            <a:off x="1432862" y="885328"/>
            <a:ext cx="4342126" cy="3133450"/>
            <a:chOff x="1291344" y="901657"/>
            <a:chExt cx="4342126" cy="3133450"/>
          </a:xfrm>
        </p:grpSpPr>
        <p:sp>
          <p:nvSpPr>
            <p:cNvPr id="237" name="Freeform 50">
              <a:extLst>
                <a:ext uri="{FF2B5EF4-FFF2-40B4-BE49-F238E27FC236}">
                  <a16:creationId xmlns:a16="http://schemas.microsoft.com/office/drawing/2014/main" id="{68269CFE-9680-8AC7-4B61-6C0150D0D6A4}"/>
                </a:ext>
              </a:extLst>
            </p:cNvPr>
            <p:cNvSpPr>
              <a:spLocks/>
            </p:cNvSpPr>
            <p:nvPr/>
          </p:nvSpPr>
          <p:spPr bwMode="auto">
            <a:xfrm>
              <a:off x="1291344" y="931676"/>
              <a:ext cx="3529110" cy="3074840"/>
            </a:xfrm>
            <a:custGeom>
              <a:avLst/>
              <a:gdLst>
                <a:gd name="T0" fmla="*/ 0 w 2535"/>
                <a:gd name="T1" fmla="*/ 0 h 2151"/>
                <a:gd name="T2" fmla="*/ 126 w 2535"/>
                <a:gd name="T3" fmla="*/ 0 h 2151"/>
                <a:gd name="T4" fmla="*/ 126 w 2535"/>
                <a:gd name="T5" fmla="*/ 227 h 2151"/>
                <a:gd name="T6" fmla="*/ 138 w 2535"/>
                <a:gd name="T7" fmla="*/ 227 h 2151"/>
                <a:gd name="T8" fmla="*/ 138 w 2535"/>
                <a:gd name="T9" fmla="*/ 341 h 2151"/>
                <a:gd name="T10" fmla="*/ 155 w 2535"/>
                <a:gd name="T11" fmla="*/ 341 h 2151"/>
                <a:gd name="T12" fmla="*/ 155 w 2535"/>
                <a:gd name="T13" fmla="*/ 455 h 2151"/>
                <a:gd name="T14" fmla="*/ 201 w 2535"/>
                <a:gd name="T15" fmla="*/ 455 h 2151"/>
                <a:gd name="T16" fmla="*/ 201 w 2535"/>
                <a:gd name="T17" fmla="*/ 569 h 2151"/>
                <a:gd name="T18" fmla="*/ 236 w 2535"/>
                <a:gd name="T19" fmla="*/ 569 h 2151"/>
                <a:gd name="T20" fmla="*/ 236 w 2535"/>
                <a:gd name="T21" fmla="*/ 683 h 2151"/>
                <a:gd name="T22" fmla="*/ 241 w 2535"/>
                <a:gd name="T23" fmla="*/ 683 h 2151"/>
                <a:gd name="T24" fmla="*/ 241 w 2535"/>
                <a:gd name="T25" fmla="*/ 797 h 2151"/>
                <a:gd name="T26" fmla="*/ 259 w 2535"/>
                <a:gd name="T27" fmla="*/ 797 h 2151"/>
                <a:gd name="T28" fmla="*/ 259 w 2535"/>
                <a:gd name="T29" fmla="*/ 911 h 2151"/>
                <a:gd name="T30" fmla="*/ 276 w 2535"/>
                <a:gd name="T31" fmla="*/ 911 h 2151"/>
                <a:gd name="T32" fmla="*/ 276 w 2535"/>
                <a:gd name="T33" fmla="*/ 1025 h 2151"/>
                <a:gd name="T34" fmla="*/ 316 w 2535"/>
                <a:gd name="T35" fmla="*/ 1025 h 2151"/>
                <a:gd name="T36" fmla="*/ 316 w 2535"/>
                <a:gd name="T37" fmla="*/ 1138 h 2151"/>
                <a:gd name="T38" fmla="*/ 408 w 2535"/>
                <a:gd name="T39" fmla="*/ 1138 h 2151"/>
                <a:gd name="T40" fmla="*/ 408 w 2535"/>
                <a:gd name="T41" fmla="*/ 1265 h 2151"/>
                <a:gd name="T42" fmla="*/ 489 w 2535"/>
                <a:gd name="T43" fmla="*/ 1265 h 2151"/>
                <a:gd name="T44" fmla="*/ 489 w 2535"/>
                <a:gd name="T45" fmla="*/ 1392 h 2151"/>
                <a:gd name="T46" fmla="*/ 564 w 2535"/>
                <a:gd name="T47" fmla="*/ 1392 h 2151"/>
                <a:gd name="T48" fmla="*/ 564 w 2535"/>
                <a:gd name="T49" fmla="*/ 1518 h 2151"/>
                <a:gd name="T50" fmla="*/ 604 w 2535"/>
                <a:gd name="T51" fmla="*/ 1518 h 2151"/>
                <a:gd name="T52" fmla="*/ 604 w 2535"/>
                <a:gd name="T53" fmla="*/ 1644 h 2151"/>
                <a:gd name="T54" fmla="*/ 673 w 2535"/>
                <a:gd name="T55" fmla="*/ 1644 h 2151"/>
                <a:gd name="T56" fmla="*/ 673 w 2535"/>
                <a:gd name="T57" fmla="*/ 1771 h 2151"/>
                <a:gd name="T58" fmla="*/ 1190 w 2535"/>
                <a:gd name="T59" fmla="*/ 1771 h 2151"/>
                <a:gd name="T60" fmla="*/ 1190 w 2535"/>
                <a:gd name="T61" fmla="*/ 1897 h 2151"/>
                <a:gd name="T62" fmla="*/ 1816 w 2535"/>
                <a:gd name="T63" fmla="*/ 1897 h 2151"/>
                <a:gd name="T64" fmla="*/ 1816 w 2535"/>
                <a:gd name="T65" fmla="*/ 2024 h 2151"/>
                <a:gd name="T66" fmla="*/ 2339 w 2535"/>
                <a:gd name="T67" fmla="*/ 2024 h 2151"/>
                <a:gd name="T68" fmla="*/ 2339 w 2535"/>
                <a:gd name="T69" fmla="*/ 2151 h 2151"/>
                <a:gd name="T70" fmla="*/ 2535 w 2535"/>
                <a:gd name="T71" fmla="*/ 2151 h 2151"/>
                <a:gd name="T72" fmla="*/ 2535 w 2535"/>
                <a:gd name="T73" fmla="*/ 2151 h 21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</a:cxnLst>
              <a:rect l="0" t="0" r="r" b="b"/>
              <a:pathLst>
                <a:path w="2535" h="2151">
                  <a:moveTo>
                    <a:pt x="0" y="0"/>
                  </a:moveTo>
                  <a:lnTo>
                    <a:pt x="126" y="0"/>
                  </a:lnTo>
                  <a:lnTo>
                    <a:pt x="126" y="227"/>
                  </a:lnTo>
                  <a:lnTo>
                    <a:pt x="138" y="227"/>
                  </a:lnTo>
                  <a:lnTo>
                    <a:pt x="138" y="341"/>
                  </a:lnTo>
                  <a:lnTo>
                    <a:pt x="155" y="341"/>
                  </a:lnTo>
                  <a:lnTo>
                    <a:pt x="155" y="455"/>
                  </a:lnTo>
                  <a:lnTo>
                    <a:pt x="201" y="455"/>
                  </a:lnTo>
                  <a:lnTo>
                    <a:pt x="201" y="569"/>
                  </a:lnTo>
                  <a:lnTo>
                    <a:pt x="236" y="569"/>
                  </a:lnTo>
                  <a:lnTo>
                    <a:pt x="236" y="683"/>
                  </a:lnTo>
                  <a:lnTo>
                    <a:pt x="241" y="683"/>
                  </a:lnTo>
                  <a:lnTo>
                    <a:pt x="241" y="797"/>
                  </a:lnTo>
                  <a:lnTo>
                    <a:pt x="259" y="797"/>
                  </a:lnTo>
                  <a:lnTo>
                    <a:pt x="259" y="911"/>
                  </a:lnTo>
                  <a:lnTo>
                    <a:pt x="276" y="911"/>
                  </a:lnTo>
                  <a:lnTo>
                    <a:pt x="276" y="1025"/>
                  </a:lnTo>
                  <a:lnTo>
                    <a:pt x="316" y="1025"/>
                  </a:lnTo>
                  <a:lnTo>
                    <a:pt x="316" y="1138"/>
                  </a:lnTo>
                  <a:lnTo>
                    <a:pt x="408" y="1138"/>
                  </a:lnTo>
                  <a:lnTo>
                    <a:pt x="408" y="1265"/>
                  </a:lnTo>
                  <a:lnTo>
                    <a:pt x="489" y="1265"/>
                  </a:lnTo>
                  <a:lnTo>
                    <a:pt x="489" y="1392"/>
                  </a:lnTo>
                  <a:lnTo>
                    <a:pt x="564" y="1392"/>
                  </a:lnTo>
                  <a:lnTo>
                    <a:pt x="564" y="1518"/>
                  </a:lnTo>
                  <a:lnTo>
                    <a:pt x="604" y="1518"/>
                  </a:lnTo>
                  <a:lnTo>
                    <a:pt x="604" y="1644"/>
                  </a:lnTo>
                  <a:lnTo>
                    <a:pt x="673" y="1644"/>
                  </a:lnTo>
                  <a:lnTo>
                    <a:pt x="673" y="1771"/>
                  </a:lnTo>
                  <a:lnTo>
                    <a:pt x="1190" y="1771"/>
                  </a:lnTo>
                  <a:lnTo>
                    <a:pt x="1190" y="1897"/>
                  </a:lnTo>
                  <a:lnTo>
                    <a:pt x="1816" y="1897"/>
                  </a:lnTo>
                  <a:lnTo>
                    <a:pt x="1816" y="2024"/>
                  </a:lnTo>
                  <a:lnTo>
                    <a:pt x="2339" y="2024"/>
                  </a:lnTo>
                  <a:lnTo>
                    <a:pt x="2339" y="2151"/>
                  </a:lnTo>
                  <a:lnTo>
                    <a:pt x="2535" y="2151"/>
                  </a:lnTo>
                  <a:lnTo>
                    <a:pt x="2535" y="2151"/>
                  </a:lnTo>
                </a:path>
              </a:pathLst>
            </a:custGeom>
            <a:noFill/>
            <a:ln w="19050" cap="flat">
              <a:solidFill>
                <a:schemeClr val="accent6">
                  <a:lumMod val="50000"/>
                </a:schemeClr>
              </a:solidFill>
              <a:prstDash val="sys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8" name="Freeform 51">
              <a:extLst>
                <a:ext uri="{FF2B5EF4-FFF2-40B4-BE49-F238E27FC236}">
                  <a16:creationId xmlns:a16="http://schemas.microsoft.com/office/drawing/2014/main" id="{5892451E-CB59-92B8-0F29-5F1D0B034AA4}"/>
                </a:ext>
              </a:extLst>
            </p:cNvPr>
            <p:cNvSpPr>
              <a:spLocks/>
            </p:cNvSpPr>
            <p:nvPr/>
          </p:nvSpPr>
          <p:spPr bwMode="auto">
            <a:xfrm>
              <a:off x="1291344" y="931676"/>
              <a:ext cx="4312892" cy="1831181"/>
            </a:xfrm>
            <a:custGeom>
              <a:avLst/>
              <a:gdLst>
                <a:gd name="T0" fmla="*/ 0 w 3098"/>
                <a:gd name="T1" fmla="*/ 0 h 1281"/>
                <a:gd name="T2" fmla="*/ 126 w 3098"/>
                <a:gd name="T3" fmla="*/ 0 h 1281"/>
                <a:gd name="T4" fmla="*/ 126 w 3098"/>
                <a:gd name="T5" fmla="*/ 0 h 1281"/>
                <a:gd name="T6" fmla="*/ 443 w 3098"/>
                <a:gd name="T7" fmla="*/ 0 h 1281"/>
                <a:gd name="T8" fmla="*/ 443 w 3098"/>
                <a:gd name="T9" fmla="*/ 284 h 1281"/>
                <a:gd name="T10" fmla="*/ 816 w 3098"/>
                <a:gd name="T11" fmla="*/ 284 h 1281"/>
                <a:gd name="T12" fmla="*/ 816 w 3098"/>
                <a:gd name="T13" fmla="*/ 616 h 1281"/>
                <a:gd name="T14" fmla="*/ 1138 w 3098"/>
                <a:gd name="T15" fmla="*/ 616 h 1281"/>
                <a:gd name="T16" fmla="*/ 1138 w 3098"/>
                <a:gd name="T17" fmla="*/ 949 h 1281"/>
                <a:gd name="T18" fmla="*/ 2081 w 3098"/>
                <a:gd name="T19" fmla="*/ 949 h 1281"/>
                <a:gd name="T20" fmla="*/ 2081 w 3098"/>
                <a:gd name="T21" fmla="*/ 1281 h 1281"/>
                <a:gd name="T22" fmla="*/ 3098 w 3098"/>
                <a:gd name="T23" fmla="*/ 1281 h 1281"/>
                <a:gd name="T24" fmla="*/ 3098 w 3098"/>
                <a:gd name="T25" fmla="*/ 1281 h 12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3098" h="1281">
                  <a:moveTo>
                    <a:pt x="0" y="0"/>
                  </a:moveTo>
                  <a:lnTo>
                    <a:pt x="126" y="0"/>
                  </a:lnTo>
                  <a:lnTo>
                    <a:pt x="126" y="0"/>
                  </a:lnTo>
                  <a:lnTo>
                    <a:pt x="443" y="0"/>
                  </a:lnTo>
                  <a:lnTo>
                    <a:pt x="443" y="284"/>
                  </a:lnTo>
                  <a:lnTo>
                    <a:pt x="816" y="284"/>
                  </a:lnTo>
                  <a:lnTo>
                    <a:pt x="816" y="616"/>
                  </a:lnTo>
                  <a:lnTo>
                    <a:pt x="1138" y="616"/>
                  </a:lnTo>
                  <a:lnTo>
                    <a:pt x="1138" y="949"/>
                  </a:lnTo>
                  <a:lnTo>
                    <a:pt x="2081" y="949"/>
                  </a:lnTo>
                  <a:lnTo>
                    <a:pt x="2081" y="1281"/>
                  </a:lnTo>
                  <a:lnTo>
                    <a:pt x="3098" y="1281"/>
                  </a:lnTo>
                  <a:lnTo>
                    <a:pt x="3098" y="1281"/>
                  </a:lnTo>
                </a:path>
              </a:pathLst>
            </a:custGeom>
            <a:noFill/>
            <a:ln w="19050" cap="flat">
              <a:solidFill>
                <a:srgbClr val="6600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9" name="Freeform 52">
              <a:extLst>
                <a:ext uri="{FF2B5EF4-FFF2-40B4-BE49-F238E27FC236}">
                  <a16:creationId xmlns:a16="http://schemas.microsoft.com/office/drawing/2014/main" id="{6FB696A5-68E3-440B-E5F3-5A3B1A2299E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774421" y="2528421"/>
              <a:ext cx="58470" cy="60039"/>
            </a:xfrm>
            <a:custGeom>
              <a:avLst/>
              <a:gdLst>
                <a:gd name="T0" fmla="*/ 0 w 42"/>
                <a:gd name="T1" fmla="*/ 21 h 42"/>
                <a:gd name="T2" fmla="*/ 42 w 42"/>
                <a:gd name="T3" fmla="*/ 21 h 42"/>
                <a:gd name="T4" fmla="*/ 21 w 42"/>
                <a:gd name="T5" fmla="*/ 0 h 42"/>
                <a:gd name="T6" fmla="*/ 21 w 42"/>
                <a:gd name="T7" fmla="*/ 42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2" h="42">
                  <a:moveTo>
                    <a:pt x="0" y="21"/>
                  </a:moveTo>
                  <a:lnTo>
                    <a:pt x="42" y="21"/>
                  </a:lnTo>
                  <a:moveTo>
                    <a:pt x="21" y="0"/>
                  </a:moveTo>
                  <a:lnTo>
                    <a:pt x="21" y="42"/>
                  </a:lnTo>
                </a:path>
              </a:pathLst>
            </a:custGeom>
            <a:noFill/>
            <a:ln w="19050" cap="rnd">
              <a:solidFill>
                <a:schemeClr val="accent6">
                  <a:lumMod val="50000"/>
                </a:schemeClr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0" name="Freeform 53">
              <a:extLst>
                <a:ext uri="{FF2B5EF4-FFF2-40B4-BE49-F238E27FC236}">
                  <a16:creationId xmlns:a16="http://schemas.microsoft.com/office/drawing/2014/main" id="{B4A3A520-7176-BB5B-0F6E-DDFC8D14211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791218" y="3975068"/>
              <a:ext cx="58470" cy="60039"/>
            </a:xfrm>
            <a:custGeom>
              <a:avLst/>
              <a:gdLst>
                <a:gd name="T0" fmla="*/ 0 w 42"/>
                <a:gd name="T1" fmla="*/ 22 h 42"/>
                <a:gd name="T2" fmla="*/ 42 w 42"/>
                <a:gd name="T3" fmla="*/ 22 h 42"/>
                <a:gd name="T4" fmla="*/ 21 w 42"/>
                <a:gd name="T5" fmla="*/ 0 h 42"/>
                <a:gd name="T6" fmla="*/ 21 w 42"/>
                <a:gd name="T7" fmla="*/ 42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2" h="42">
                  <a:moveTo>
                    <a:pt x="0" y="22"/>
                  </a:moveTo>
                  <a:lnTo>
                    <a:pt x="42" y="22"/>
                  </a:lnTo>
                  <a:moveTo>
                    <a:pt x="21" y="0"/>
                  </a:moveTo>
                  <a:lnTo>
                    <a:pt x="21" y="42"/>
                  </a:lnTo>
                </a:path>
              </a:pathLst>
            </a:custGeom>
            <a:noFill/>
            <a:ln w="19050" cap="rnd">
              <a:solidFill>
                <a:schemeClr val="accent6">
                  <a:lumMod val="50000"/>
                </a:schemeClr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1" name="Freeform 54">
              <a:extLst>
                <a:ext uri="{FF2B5EF4-FFF2-40B4-BE49-F238E27FC236}">
                  <a16:creationId xmlns:a16="http://schemas.microsoft.com/office/drawing/2014/main" id="{27E2AC8C-50D1-AC5A-B931-22BFCA38A1C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558637" y="901657"/>
              <a:ext cx="58470" cy="60039"/>
            </a:xfrm>
            <a:custGeom>
              <a:avLst/>
              <a:gdLst>
                <a:gd name="T0" fmla="*/ 0 w 42"/>
                <a:gd name="T1" fmla="*/ 21 h 42"/>
                <a:gd name="T2" fmla="*/ 42 w 42"/>
                <a:gd name="T3" fmla="*/ 21 h 42"/>
                <a:gd name="T4" fmla="*/ 21 w 42"/>
                <a:gd name="T5" fmla="*/ 0 h 42"/>
                <a:gd name="T6" fmla="*/ 21 w 42"/>
                <a:gd name="T7" fmla="*/ 42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2" h="42">
                  <a:moveTo>
                    <a:pt x="0" y="21"/>
                  </a:moveTo>
                  <a:lnTo>
                    <a:pt x="42" y="21"/>
                  </a:lnTo>
                  <a:moveTo>
                    <a:pt x="21" y="0"/>
                  </a:moveTo>
                  <a:lnTo>
                    <a:pt x="21" y="42"/>
                  </a:lnTo>
                </a:path>
              </a:pathLst>
            </a:custGeom>
            <a:noFill/>
            <a:ln w="19050" cap="rnd">
              <a:solidFill>
                <a:srgbClr val="6600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2" name="Freeform 55">
              <a:extLst>
                <a:ext uri="{FF2B5EF4-FFF2-40B4-BE49-F238E27FC236}">
                  <a16:creationId xmlns:a16="http://schemas.microsoft.com/office/drawing/2014/main" id="{C226D8FD-EDC2-B0E1-136D-592E5467F8A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327106" y="1309062"/>
              <a:ext cx="58470" cy="58610"/>
            </a:xfrm>
            <a:custGeom>
              <a:avLst/>
              <a:gdLst>
                <a:gd name="T0" fmla="*/ 0 w 42"/>
                <a:gd name="T1" fmla="*/ 20 h 41"/>
                <a:gd name="T2" fmla="*/ 42 w 42"/>
                <a:gd name="T3" fmla="*/ 20 h 41"/>
                <a:gd name="T4" fmla="*/ 20 w 42"/>
                <a:gd name="T5" fmla="*/ 0 h 41"/>
                <a:gd name="T6" fmla="*/ 20 w 42"/>
                <a:gd name="T7" fmla="*/ 41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2" h="41">
                  <a:moveTo>
                    <a:pt x="0" y="20"/>
                  </a:moveTo>
                  <a:lnTo>
                    <a:pt x="42" y="20"/>
                  </a:lnTo>
                  <a:moveTo>
                    <a:pt x="20" y="0"/>
                  </a:moveTo>
                  <a:lnTo>
                    <a:pt x="20" y="41"/>
                  </a:lnTo>
                </a:path>
              </a:pathLst>
            </a:custGeom>
            <a:noFill/>
            <a:ln w="19050" cap="rnd">
              <a:solidFill>
                <a:srgbClr val="6600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3" name="Freeform 56">
              <a:extLst>
                <a:ext uri="{FF2B5EF4-FFF2-40B4-BE49-F238E27FC236}">
                  <a16:creationId xmlns:a16="http://schemas.microsoft.com/office/drawing/2014/main" id="{2EFC5BAA-0C4F-CA59-A4A5-E3C4F434EB7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406983" y="2732838"/>
              <a:ext cx="58470" cy="58610"/>
            </a:xfrm>
            <a:custGeom>
              <a:avLst/>
              <a:gdLst>
                <a:gd name="T0" fmla="*/ 0 w 42"/>
                <a:gd name="T1" fmla="*/ 21 h 41"/>
                <a:gd name="T2" fmla="*/ 42 w 42"/>
                <a:gd name="T3" fmla="*/ 21 h 41"/>
                <a:gd name="T4" fmla="*/ 21 w 42"/>
                <a:gd name="T5" fmla="*/ 0 h 41"/>
                <a:gd name="T6" fmla="*/ 21 w 42"/>
                <a:gd name="T7" fmla="*/ 41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2" h="41">
                  <a:moveTo>
                    <a:pt x="0" y="21"/>
                  </a:moveTo>
                  <a:lnTo>
                    <a:pt x="42" y="21"/>
                  </a:lnTo>
                  <a:moveTo>
                    <a:pt x="21" y="0"/>
                  </a:moveTo>
                  <a:lnTo>
                    <a:pt x="21" y="41"/>
                  </a:lnTo>
                </a:path>
              </a:pathLst>
            </a:custGeom>
            <a:noFill/>
            <a:ln w="19050" cap="rnd">
              <a:solidFill>
                <a:srgbClr val="6600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4" name="Freeform 57">
              <a:extLst>
                <a:ext uri="{FF2B5EF4-FFF2-40B4-BE49-F238E27FC236}">
                  <a16:creationId xmlns:a16="http://schemas.microsoft.com/office/drawing/2014/main" id="{367E82CD-03F9-AFCA-C753-03F72D0A5C0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846904" y="2732838"/>
              <a:ext cx="58470" cy="58610"/>
            </a:xfrm>
            <a:custGeom>
              <a:avLst/>
              <a:gdLst>
                <a:gd name="T0" fmla="*/ 0 w 42"/>
                <a:gd name="T1" fmla="*/ 21 h 41"/>
                <a:gd name="T2" fmla="*/ 42 w 42"/>
                <a:gd name="T3" fmla="*/ 21 h 41"/>
                <a:gd name="T4" fmla="*/ 21 w 42"/>
                <a:gd name="T5" fmla="*/ 0 h 41"/>
                <a:gd name="T6" fmla="*/ 21 w 42"/>
                <a:gd name="T7" fmla="*/ 41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2" h="41">
                  <a:moveTo>
                    <a:pt x="0" y="21"/>
                  </a:moveTo>
                  <a:lnTo>
                    <a:pt x="42" y="21"/>
                  </a:lnTo>
                  <a:moveTo>
                    <a:pt x="21" y="0"/>
                  </a:moveTo>
                  <a:lnTo>
                    <a:pt x="21" y="41"/>
                  </a:lnTo>
                </a:path>
              </a:pathLst>
            </a:custGeom>
            <a:noFill/>
            <a:ln w="19050" cap="rnd">
              <a:solidFill>
                <a:srgbClr val="6600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5" name="Freeform 58">
              <a:extLst>
                <a:ext uri="{FF2B5EF4-FFF2-40B4-BE49-F238E27FC236}">
                  <a16:creationId xmlns:a16="http://schemas.microsoft.com/office/drawing/2014/main" id="{A73AB84F-2672-3BFE-C14C-30541163735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575000" y="2732838"/>
              <a:ext cx="58470" cy="58610"/>
            </a:xfrm>
            <a:custGeom>
              <a:avLst/>
              <a:gdLst>
                <a:gd name="T0" fmla="*/ 0 w 42"/>
                <a:gd name="T1" fmla="*/ 21 h 41"/>
                <a:gd name="T2" fmla="*/ 42 w 42"/>
                <a:gd name="T3" fmla="*/ 21 h 41"/>
                <a:gd name="T4" fmla="*/ 21 w 42"/>
                <a:gd name="T5" fmla="*/ 0 h 41"/>
                <a:gd name="T6" fmla="*/ 21 w 42"/>
                <a:gd name="T7" fmla="*/ 41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2" h="41">
                  <a:moveTo>
                    <a:pt x="0" y="21"/>
                  </a:moveTo>
                  <a:lnTo>
                    <a:pt x="42" y="21"/>
                  </a:lnTo>
                  <a:moveTo>
                    <a:pt x="21" y="0"/>
                  </a:moveTo>
                  <a:lnTo>
                    <a:pt x="21" y="41"/>
                  </a:lnTo>
                </a:path>
              </a:pathLst>
            </a:custGeom>
            <a:noFill/>
            <a:ln w="19050" cap="rnd">
              <a:solidFill>
                <a:srgbClr val="6600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4764433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08</TotalTime>
  <Words>200</Words>
  <Application>Microsoft Office PowerPoint</Application>
  <PresentationFormat>ワイド画面</PresentationFormat>
  <Paragraphs>4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雄一 本間</dc:creator>
  <cp:lastModifiedBy>雄一 本間</cp:lastModifiedBy>
  <cp:revision>53</cp:revision>
  <dcterms:created xsi:type="dcterms:W3CDTF">2024-11-23T09:58:41Z</dcterms:created>
  <dcterms:modified xsi:type="dcterms:W3CDTF">2025-04-09T08:27:34Z</dcterms:modified>
</cp:coreProperties>
</file>